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46F890A9-2807-4EBB-B81D-B2AA78EC7F39}" styleName="Dark Style 2 - Accent 5/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74C1A8A3-306A-4EB7-A6B1-4F7E0EB9C5D6}" styleName="Medium Style 3 - Accent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5A111915-BE36-4E01-A7E5-04B1672EAD32}" styleName="Light Style 2 - Acc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83" d="100"/>
          <a:sy n="83" d="100"/>
        </p:scale>
        <p:origin x="3139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27C4A-84FE-4036-923A-C40AC79545E8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F69EF-5C00-44A4-87B0-D6E03E88C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4547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27C4A-84FE-4036-923A-C40AC79545E8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F69EF-5C00-44A4-87B0-D6E03E88C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80488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27C4A-84FE-4036-923A-C40AC79545E8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F69EF-5C00-44A4-87B0-D6E03E88C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9127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27C4A-84FE-4036-923A-C40AC79545E8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F69EF-5C00-44A4-87B0-D6E03E88C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57985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27C4A-84FE-4036-923A-C40AC79545E8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F69EF-5C00-44A4-87B0-D6E03E88C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74578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27C4A-84FE-4036-923A-C40AC79545E8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F69EF-5C00-44A4-87B0-D6E03E88C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5564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27C4A-84FE-4036-923A-C40AC79545E8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F69EF-5C00-44A4-87B0-D6E03E88C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4932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27C4A-84FE-4036-923A-C40AC79545E8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F69EF-5C00-44A4-87B0-D6E03E88C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65484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27C4A-84FE-4036-923A-C40AC79545E8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F69EF-5C00-44A4-87B0-D6E03E88C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0316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27C4A-84FE-4036-923A-C40AC79545E8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F69EF-5C00-44A4-87B0-D6E03E88C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023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27C4A-84FE-4036-923A-C40AC79545E8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F69EF-5C00-44A4-87B0-D6E03E88C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32097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227C4A-84FE-4036-923A-C40AC79545E8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BF69EF-5C00-44A4-87B0-D6E03E88C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11386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7">
            <a:extLst>
              <a:ext uri="{FF2B5EF4-FFF2-40B4-BE49-F238E27FC236}">
                <a16:creationId xmlns:a16="http://schemas.microsoft.com/office/drawing/2014/main" id="{EC96E134-9330-4D9D-9CFC-320663AC67D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30115151"/>
              </p:ext>
            </p:extLst>
          </p:nvPr>
        </p:nvGraphicFramePr>
        <p:xfrm>
          <a:off x="867926" y="962762"/>
          <a:ext cx="6036548" cy="5565648"/>
        </p:xfrm>
        <a:graphic>
          <a:graphicData uri="http://schemas.openxmlformats.org/drawingml/2006/table">
            <a:tbl>
              <a:tblPr firstRow="1" bandRow="1">
                <a:tableStyleId>{5A111915-BE36-4E01-A7E5-04B1672EAD32}</a:tableStyleId>
              </a:tblPr>
              <a:tblGrid>
                <a:gridCol w="898924">
                  <a:extLst>
                    <a:ext uri="{9D8B030D-6E8A-4147-A177-3AD203B41FA5}">
                      <a16:colId xmlns:a16="http://schemas.microsoft.com/office/drawing/2014/main" val="562614945"/>
                    </a:ext>
                  </a:extLst>
                </a:gridCol>
                <a:gridCol w="1205233">
                  <a:extLst>
                    <a:ext uri="{9D8B030D-6E8A-4147-A177-3AD203B41FA5}">
                      <a16:colId xmlns:a16="http://schemas.microsoft.com/office/drawing/2014/main" val="3452413016"/>
                    </a:ext>
                  </a:extLst>
                </a:gridCol>
                <a:gridCol w="3932391">
                  <a:extLst>
                    <a:ext uri="{9D8B030D-6E8A-4147-A177-3AD203B41FA5}">
                      <a16:colId xmlns:a16="http://schemas.microsoft.com/office/drawing/2014/main" val="2356829938"/>
                    </a:ext>
                  </a:extLst>
                </a:gridCol>
              </a:tblGrid>
              <a:tr h="234327">
                <a:tc>
                  <a:txBody>
                    <a:bodyPr/>
                    <a:lstStyle/>
                    <a:p>
                      <a:r>
                        <a:rPr lang="en-US" sz="1400" dirty="0"/>
                        <a:t>Iron categor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Photographic examp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/>
                        <a:t>Description of spleen sections stained with Perl’s Prussian blue iron stain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60774410"/>
                  </a:ext>
                </a:extLst>
              </a:tr>
              <a:tr h="841248"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+mn-lt"/>
                        </a:rPr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2A2D35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nly observed in fish from Lake Ngami, bright blue staining throughout capsule and parenchyma with dark blue melano-macrophage aggregates and small intra- and extra-cellular particles.</a:t>
                      </a:r>
                      <a:endParaRPr lang="en-US" sz="1200" dirty="0">
                        <a:effectLst/>
                        <a:latin typeface="+mn-lt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09809846"/>
                  </a:ext>
                </a:extLst>
              </a:tr>
              <a:tr h="841248"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+mn-lt"/>
                        </a:rPr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>
                        <a:latin typeface="+mn-lt"/>
                      </a:endParaRPr>
                    </a:p>
                    <a:p>
                      <a:endParaRPr lang="en-US" dirty="0">
                        <a:latin typeface="+mn-lt"/>
                      </a:endParaRPr>
                    </a:p>
                    <a:p>
                      <a:endParaRPr lang="en-US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2A2D35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ost (95-100%) melano-macrophage aggregates are bright to dark blue. Light blue staining also visible throughout most of the splenic parenchyma.</a:t>
                      </a:r>
                      <a:endParaRPr lang="en-US" sz="1200" dirty="0">
                        <a:effectLst/>
                        <a:latin typeface="+mn-lt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61822355"/>
                  </a:ext>
                </a:extLst>
              </a:tr>
              <a:tr h="841248"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+mn-lt"/>
                        </a:rPr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>
                        <a:latin typeface="+mn-lt"/>
                      </a:endParaRPr>
                    </a:p>
                    <a:p>
                      <a:endParaRPr lang="en-US" dirty="0">
                        <a:latin typeface="+mn-lt"/>
                      </a:endParaRPr>
                    </a:p>
                    <a:p>
                      <a:endParaRPr lang="en-US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2A2D35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duced blue staining in parenchyma and capsule, compared with “Score 2” specimens; 81-100% of melano-macrophage aggregates are blue with the rest brown.</a:t>
                      </a:r>
                      <a:endParaRPr lang="en-US" sz="1200" dirty="0">
                        <a:effectLst/>
                        <a:latin typeface="+mn-lt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98598884"/>
                  </a:ext>
                </a:extLst>
              </a:tr>
              <a:tr h="841248"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+mn-lt"/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>
                        <a:latin typeface="+mn-lt"/>
                      </a:endParaRPr>
                    </a:p>
                    <a:p>
                      <a:endParaRPr lang="en-US" dirty="0">
                        <a:latin typeface="+mn-lt"/>
                      </a:endParaRPr>
                    </a:p>
                    <a:p>
                      <a:endParaRPr lang="en-US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2A2D35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lue staining mainly on edges of spleen; 21-80% of melano-macrophage aggregates are blue, or brown and blue.</a:t>
                      </a:r>
                      <a:endParaRPr lang="en-US" sz="1200" dirty="0">
                        <a:effectLst/>
                        <a:latin typeface="+mn-lt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903441603"/>
                  </a:ext>
                </a:extLst>
              </a:tr>
              <a:tr h="841248"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+mn-lt"/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>
                        <a:latin typeface="+mn-lt"/>
                      </a:endParaRPr>
                    </a:p>
                    <a:p>
                      <a:endParaRPr lang="en-US" dirty="0">
                        <a:latin typeface="+mn-lt"/>
                      </a:endParaRPr>
                    </a:p>
                    <a:p>
                      <a:endParaRPr lang="en-US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2A2D35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cattered blue staining in parenchyma or capsule, with 2-20% of melano-macrophages staining blue.</a:t>
                      </a:r>
                      <a:endParaRPr lang="en-US" sz="1200" dirty="0">
                        <a:effectLst/>
                        <a:latin typeface="+mn-lt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92233557"/>
                  </a:ext>
                </a:extLst>
              </a:tr>
              <a:tr h="841248"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+mn-lt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>
                        <a:latin typeface="+mn-lt"/>
                      </a:endParaRPr>
                    </a:p>
                    <a:p>
                      <a:endParaRPr lang="en-US" dirty="0">
                        <a:latin typeface="+mn-lt"/>
                      </a:endParaRPr>
                    </a:p>
                    <a:p>
                      <a:endParaRPr lang="en-US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2A2D35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-1% blue staining visible; usually residual staining appears in the melano-macrophage aggregates.</a:t>
                      </a:r>
                      <a:endParaRPr lang="en-US" sz="1200" dirty="0">
                        <a:effectLst/>
                        <a:latin typeface="+mn-lt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33568389"/>
                  </a:ext>
                </a:extLst>
              </a:tr>
            </a:tbl>
          </a:graphicData>
        </a:graphic>
      </p:graphicFrame>
      <p:grpSp>
        <p:nvGrpSpPr>
          <p:cNvPr id="2" name="Group 1">
            <a:extLst>
              <a:ext uri="{FF2B5EF4-FFF2-40B4-BE49-F238E27FC236}">
                <a16:creationId xmlns:a16="http://schemas.microsoft.com/office/drawing/2014/main" id="{B8E2F770-816A-4CA5-A704-8733E3B1D833}"/>
              </a:ext>
            </a:extLst>
          </p:cNvPr>
          <p:cNvGrpSpPr/>
          <p:nvPr/>
        </p:nvGrpSpPr>
        <p:grpSpPr>
          <a:xfrm>
            <a:off x="1817836" y="1501394"/>
            <a:ext cx="1054735" cy="5004108"/>
            <a:chOff x="1817836" y="1501394"/>
            <a:chExt cx="1054735" cy="5004108"/>
          </a:xfrm>
        </p:grpSpPr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238BB253-6805-4C24-AB15-4B651169E35A}"/>
                </a:ext>
              </a:extLst>
            </p:cNvPr>
            <p:cNvPicPr/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17836" y="1501394"/>
              <a:ext cx="1054735" cy="790575"/>
            </a:xfrm>
            <a:prstGeom prst="rect">
              <a:avLst/>
            </a:prstGeom>
            <a:ln>
              <a:noFill/>
            </a:ln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8C1C090E-2B35-4BA8-BF9E-63DC7E5C0779}"/>
                </a:ext>
              </a:extLst>
            </p:cNvPr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17836" y="2344101"/>
              <a:ext cx="1054735" cy="790575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C254F3F4-5446-477F-9A56-A8C1E1950438}"/>
                </a:ext>
              </a:extLst>
            </p:cNvPr>
            <p:cNvPicPr/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17836" y="3186808"/>
              <a:ext cx="1054735" cy="790575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77F455AD-0094-4316-BCE1-08C4C3D3F666}"/>
                </a:ext>
              </a:extLst>
            </p:cNvPr>
            <p:cNvPicPr/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17836" y="4029515"/>
              <a:ext cx="1054735" cy="790575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34DA4D26-D801-4274-A3C0-2D433E924EBD}"/>
                </a:ext>
              </a:extLst>
            </p:cNvPr>
            <p:cNvPicPr/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17836" y="4872222"/>
              <a:ext cx="1054735" cy="790575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5DDC058C-9ACF-4218-8DCC-B6D1329443DF}"/>
                </a:ext>
              </a:extLst>
            </p:cNvPr>
            <p:cNvPicPr/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17836" y="5714927"/>
              <a:ext cx="1054735" cy="790575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2855178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6</TotalTime>
  <Words>152</Words>
  <Application>Microsoft Office PowerPoint</Application>
  <PresentationFormat>Custom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dwards, Thea M</dc:creator>
  <cp:lastModifiedBy>Edwards, Thea M</cp:lastModifiedBy>
  <cp:revision>13</cp:revision>
  <dcterms:created xsi:type="dcterms:W3CDTF">2020-04-08T20:48:34Z</dcterms:created>
  <dcterms:modified xsi:type="dcterms:W3CDTF">2020-04-09T13:53:51Z</dcterms:modified>
</cp:coreProperties>
</file>